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D58C1D-DF30-8328-AB52-7B18298959E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5CAD951-8B16-F6D4-771E-585741F7A9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4B10A3-D58D-F387-AC65-26BC73D2B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673ADF-1CE0-A666-9CDC-5E2260D02C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0480A4-98A1-D328-36A2-636D0E575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3941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557AD7-9D69-05A1-8EC2-18E5A2505F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63430C6-4C5C-7D62-6078-88C7012325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3E53CF-F64A-F3C1-1EB9-309C348E15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CF1B52-B1BA-6E02-6BEA-31DFE1F77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AFC17-6086-F36B-B927-CF9218C4BD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647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8DF579-EC13-33E4-73A5-13FF6FF5BC0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D7CB59-DCFA-A50E-5D44-9BD884C15A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04B050-37D3-0E65-7C4C-043C85DE1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5708B2-2E0B-6B51-8DB7-DDA258CA2E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FDF1FA-8532-52B6-79FD-F36876E60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1198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ACCF17-DC9F-087B-862C-6C288BE1E9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ABCFBE-82F1-CE68-44DC-9CA05A3D42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DE33A0-EA14-ED98-4F36-CC568F0CA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3D1745-B12B-0F6A-3F34-74FA3E6603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296C35-4BA9-BE9B-03D3-D2B0513F59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3405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C86888-0F75-A533-D056-B65206C96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56AFB4-E241-2500-BCF4-17B57EADCF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0289C7-9346-67FF-4584-08B8C98FA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10AD97-4DEC-AA77-670C-AFCFFDA0EA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A3661E-A0EF-15A4-E2B3-EB8717F772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202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4309B6-DB74-40A6-1208-2A2FC060E6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9E828F-3554-B945-25D0-D3224B2D2F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675942-06EF-3193-CA97-E9453E7A99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D63B59-8FFA-CAB7-C4F7-F50DD83D4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5840F0-A28F-4378-E421-91DCE7D1D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241640-9C43-A2A2-181E-9735782BCD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535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792EB5-8EB4-7FF1-7FED-4ED2C7849C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D18FFE-2A15-ADEE-CE75-44D80685C6E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5575B54-E912-7382-61D6-CE5A725F03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EA15FC2-E5B2-3975-70E7-8FAB2F2839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539692-125B-506A-0C60-19A581C2859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7ABD021-16F1-2B33-CAD8-B040C45C25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DCA8B8D-A7A5-3B74-DC3D-AE3A3160BF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E4E6EB-10A3-9ACB-C3BF-427763757C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5734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B397A3-EF4E-0827-A0BE-2DEC183E00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53E92D-8E5A-0755-FFEB-13AC628498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24D1A1C-ECF5-F64C-AEF8-EA9DB45F2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DADC09-FF80-E26C-6C5E-5DC990127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735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11F386-CB69-68D5-3147-7E5915F4C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9BC7B30-C721-371C-7464-1603FEE622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8F32201-9A5B-E0A6-D56C-5DDDA604A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5574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52B1ED-CA17-5014-08C3-E79949B7FB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CEAB1E-BB4C-41C4-99FA-C570164BCD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539886-A80B-6508-587C-20EBFC7BD8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78F9EE-7A3E-E19F-5A02-22A3D38A29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2D67BD-A62A-E980-D472-E47B21820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FDD248-35A2-A15B-6ECD-179B74D097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428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E5B20F-252C-25CF-4E82-320310DC2D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7EC4BA7-C87E-2D89-98F8-75154BA803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75841C-83E9-8523-CC09-6E85F4D746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CFBFC8-4A26-D85E-FA7D-577806FD5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0C8CC0-E111-092C-087A-F91989678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0F321F-0DBC-597C-A85A-1649937E96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685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952FA8-4675-7A19-CFE0-6A532F4912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B01688-76FA-AAFE-1D53-17411D378C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59F7D3-B852-BB8C-4755-3A4D1CE3C81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A3778-36BF-454B-B946-3D8D39B338A9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B4B977-87AC-E9C4-68F3-4AC7E6A5AAA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D83B91-2CFE-9559-4356-8AB637726E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7469E-72D5-6C4C-8035-7AA51EF054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487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TextBox 30">
            <a:extLst>
              <a:ext uri="{FF2B5EF4-FFF2-40B4-BE49-F238E27FC236}">
                <a16:creationId xmlns:a16="http://schemas.microsoft.com/office/drawing/2014/main" id="{993F8EBA-61DC-5696-9FC2-BE6F6FEFF64F}"/>
              </a:ext>
            </a:extLst>
          </p:cNvPr>
          <p:cNvSpPr txBox="1"/>
          <p:nvPr/>
        </p:nvSpPr>
        <p:spPr>
          <a:xfrm>
            <a:off x="4435069" y="51720"/>
            <a:ext cx="361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Histones vs Diabetes Condition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0301563-C3EC-6E40-D8AB-0EE51F63A10D}"/>
              </a:ext>
            </a:extLst>
          </p:cNvPr>
          <p:cNvGrpSpPr/>
          <p:nvPr/>
        </p:nvGrpSpPr>
        <p:grpSpPr>
          <a:xfrm>
            <a:off x="1533984" y="681494"/>
            <a:ext cx="8311658" cy="440373"/>
            <a:chOff x="1533984" y="622255"/>
            <a:chExt cx="8311658" cy="440373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5A221ED-D3E0-E126-56B1-8454622E2308}"/>
                </a:ext>
              </a:extLst>
            </p:cNvPr>
            <p:cNvSpPr txBox="1"/>
            <p:nvPr/>
          </p:nvSpPr>
          <p:spPr>
            <a:xfrm>
              <a:off x="1533984" y="622255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A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5CD6DCA-9690-9C75-22B5-8A99EB18EC27}"/>
                </a:ext>
              </a:extLst>
            </p:cNvPr>
            <p:cNvSpPr txBox="1"/>
            <p:nvPr/>
          </p:nvSpPr>
          <p:spPr>
            <a:xfrm>
              <a:off x="5409740" y="754851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B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F663B55-16EB-3FB6-8ABC-304AD1FC31B2}"/>
                </a:ext>
              </a:extLst>
            </p:cNvPr>
            <p:cNvSpPr txBox="1"/>
            <p:nvPr/>
          </p:nvSpPr>
          <p:spPr>
            <a:xfrm>
              <a:off x="9433350" y="740902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561E8AB2-EA4B-2611-97E1-0052551CC95F}"/>
              </a:ext>
            </a:extLst>
          </p:cNvPr>
          <p:cNvGrpSpPr/>
          <p:nvPr/>
        </p:nvGrpSpPr>
        <p:grpSpPr>
          <a:xfrm>
            <a:off x="1533984" y="3782218"/>
            <a:ext cx="8669989" cy="352823"/>
            <a:chOff x="1557902" y="6134553"/>
            <a:chExt cx="8669989" cy="352823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270D1C5-EA9D-ED73-5707-FE9112FE6882}"/>
                </a:ext>
              </a:extLst>
            </p:cNvPr>
            <p:cNvSpPr txBox="1"/>
            <p:nvPr/>
          </p:nvSpPr>
          <p:spPr>
            <a:xfrm>
              <a:off x="1557902" y="6179599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6C5270D-B8C5-0E35-AA92-65831C6C03A0}"/>
                </a:ext>
              </a:extLst>
            </p:cNvPr>
            <p:cNvSpPr txBox="1"/>
            <p:nvPr/>
          </p:nvSpPr>
          <p:spPr>
            <a:xfrm>
              <a:off x="5290194" y="6163119"/>
              <a:ext cx="7088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/H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7EFB4AD4-3BD8-6AFD-91A4-8A90462085C9}"/>
                </a:ext>
              </a:extLst>
            </p:cNvPr>
            <p:cNvSpPr txBox="1"/>
            <p:nvPr/>
          </p:nvSpPr>
          <p:spPr>
            <a:xfrm>
              <a:off x="9097838" y="6134553"/>
              <a:ext cx="11300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MacroH2A1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E5400918-B731-9A2E-FB2A-6D594A13AFE1}"/>
              </a:ext>
            </a:extLst>
          </p:cNvPr>
          <p:cNvSpPr txBox="1"/>
          <p:nvPr/>
        </p:nvSpPr>
        <p:spPr>
          <a:xfrm>
            <a:off x="3249301" y="668681"/>
            <a:ext cx="335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23F333D-C1DC-30C4-D7A1-49F43478F588}"/>
              </a:ext>
            </a:extLst>
          </p:cNvPr>
          <p:cNvSpPr txBox="1"/>
          <p:nvPr/>
        </p:nvSpPr>
        <p:spPr>
          <a:xfrm>
            <a:off x="3223500" y="813630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Type 2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C08EDE0-9388-4340-D3DB-D6884D3B3D7E}"/>
              </a:ext>
            </a:extLst>
          </p:cNvPr>
          <p:cNvSpPr/>
          <p:nvPr/>
        </p:nvSpPr>
        <p:spPr>
          <a:xfrm>
            <a:off x="3140601" y="759853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25A4FE0E-FFD3-86F9-16A7-A87FF6A19351}"/>
              </a:ext>
            </a:extLst>
          </p:cNvPr>
          <p:cNvSpPr/>
          <p:nvPr/>
        </p:nvSpPr>
        <p:spPr>
          <a:xfrm>
            <a:off x="3140601" y="896009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C9CE782-9606-F83B-4958-7B6FFA15C536}"/>
              </a:ext>
            </a:extLst>
          </p:cNvPr>
          <p:cNvSpPr txBox="1"/>
          <p:nvPr/>
        </p:nvSpPr>
        <p:spPr>
          <a:xfrm>
            <a:off x="606734" y="3192244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9017DBB-C61C-6AB0-C8C5-D43B972B6773}"/>
              </a:ext>
            </a:extLst>
          </p:cNvPr>
          <p:cNvSpPr txBox="1"/>
          <p:nvPr/>
        </p:nvSpPr>
        <p:spPr>
          <a:xfrm>
            <a:off x="1437591" y="3174867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90B68CC-AE58-DA8D-2985-87390284519F}"/>
              </a:ext>
            </a:extLst>
          </p:cNvPr>
          <p:cNvSpPr txBox="1"/>
          <p:nvPr/>
        </p:nvSpPr>
        <p:spPr>
          <a:xfrm>
            <a:off x="2369437" y="3175195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pic>
        <p:nvPicPr>
          <p:cNvPr id="24" name="Content Placeholder 6">
            <a:extLst>
              <a:ext uri="{FF2B5EF4-FFF2-40B4-BE49-F238E27FC236}">
                <a16:creationId xmlns:a16="http://schemas.microsoft.com/office/drawing/2014/main" id="{9CCB16F1-315C-49F2-60D9-D40503E2C07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3" r="10327" b="5866"/>
          <a:stretch/>
        </p:blipFill>
        <p:spPr>
          <a:xfrm>
            <a:off x="270833" y="1009611"/>
            <a:ext cx="3121335" cy="2195352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4D494AA1-C8AC-B223-FFB5-5852CCFED7D9}"/>
              </a:ext>
            </a:extLst>
          </p:cNvPr>
          <p:cNvSpPr txBox="1"/>
          <p:nvPr/>
        </p:nvSpPr>
        <p:spPr>
          <a:xfrm rot="16200000">
            <a:off x="34648" y="2189201"/>
            <a:ext cx="394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04A3F09-9D66-51C0-5D46-E1FD03DBA4E8}"/>
              </a:ext>
            </a:extLst>
          </p:cNvPr>
          <p:cNvSpPr txBox="1"/>
          <p:nvPr/>
        </p:nvSpPr>
        <p:spPr>
          <a:xfrm>
            <a:off x="6952173" y="746086"/>
            <a:ext cx="335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E41AB66-0721-47DB-26EF-4736D7B2ED88}"/>
              </a:ext>
            </a:extLst>
          </p:cNvPr>
          <p:cNvSpPr txBox="1"/>
          <p:nvPr/>
        </p:nvSpPr>
        <p:spPr>
          <a:xfrm>
            <a:off x="6926372" y="891035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Type 2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73E6B273-FF78-2312-1C2F-A9344EAE5811}"/>
              </a:ext>
            </a:extLst>
          </p:cNvPr>
          <p:cNvSpPr/>
          <p:nvPr/>
        </p:nvSpPr>
        <p:spPr>
          <a:xfrm>
            <a:off x="6843473" y="837258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330B394C-AE52-6456-B078-AD8E713208D4}"/>
              </a:ext>
            </a:extLst>
          </p:cNvPr>
          <p:cNvSpPr/>
          <p:nvPr/>
        </p:nvSpPr>
        <p:spPr>
          <a:xfrm>
            <a:off x="6843473" y="973414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21528B2-60C0-38D9-F348-EAE2A9D7B131}"/>
              </a:ext>
            </a:extLst>
          </p:cNvPr>
          <p:cNvSpPr txBox="1"/>
          <p:nvPr/>
        </p:nvSpPr>
        <p:spPr>
          <a:xfrm>
            <a:off x="4576666" y="313685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637E418-F6F6-001B-5870-B39DFC96BDF2}"/>
              </a:ext>
            </a:extLst>
          </p:cNvPr>
          <p:cNvSpPr txBox="1"/>
          <p:nvPr/>
        </p:nvSpPr>
        <p:spPr>
          <a:xfrm>
            <a:off x="5273993" y="3128197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2EF5A6B-AC40-2F88-877A-9391F96D9253}"/>
              </a:ext>
            </a:extLst>
          </p:cNvPr>
          <p:cNvSpPr txBox="1"/>
          <p:nvPr/>
        </p:nvSpPr>
        <p:spPr>
          <a:xfrm>
            <a:off x="6072309" y="3140637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6C73FEE-51D9-476F-AFF8-2F432D91CCDB}"/>
              </a:ext>
            </a:extLst>
          </p:cNvPr>
          <p:cNvSpPr txBox="1"/>
          <p:nvPr/>
        </p:nvSpPr>
        <p:spPr>
          <a:xfrm rot="16200000">
            <a:off x="3764173" y="2220985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B</a:t>
            </a:r>
          </a:p>
        </p:txBody>
      </p:sp>
      <p:pic>
        <p:nvPicPr>
          <p:cNvPr id="37" name="Picture 36">
            <a:extLst>
              <a:ext uri="{FF2B5EF4-FFF2-40B4-BE49-F238E27FC236}">
                <a16:creationId xmlns:a16="http://schemas.microsoft.com/office/drawing/2014/main" id="{177644A8-271E-D864-67C6-79148A3CA4C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22" r="9628" b="5707"/>
          <a:stretch/>
        </p:blipFill>
        <p:spPr>
          <a:xfrm>
            <a:off x="4091494" y="1204246"/>
            <a:ext cx="3121335" cy="1915127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31ADCE73-135D-D820-FDC9-60598C08C0D8}"/>
              </a:ext>
            </a:extLst>
          </p:cNvPr>
          <p:cNvSpPr txBox="1"/>
          <p:nvPr/>
        </p:nvSpPr>
        <p:spPr>
          <a:xfrm>
            <a:off x="10871938" y="736443"/>
            <a:ext cx="335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F2FDE01-F0E5-7B6A-DA86-7B7A3F14CBCD}"/>
              </a:ext>
            </a:extLst>
          </p:cNvPr>
          <p:cNvSpPr txBox="1"/>
          <p:nvPr/>
        </p:nvSpPr>
        <p:spPr>
          <a:xfrm>
            <a:off x="10846137" y="881392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Type 2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3F7856C3-EE9A-C1B1-3658-9E5B70D9E830}"/>
              </a:ext>
            </a:extLst>
          </p:cNvPr>
          <p:cNvSpPr/>
          <p:nvPr/>
        </p:nvSpPr>
        <p:spPr>
          <a:xfrm>
            <a:off x="10763238" y="827615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BBA169D1-B1F3-AF5D-EDF7-9543D4900560}"/>
              </a:ext>
            </a:extLst>
          </p:cNvPr>
          <p:cNvSpPr/>
          <p:nvPr/>
        </p:nvSpPr>
        <p:spPr>
          <a:xfrm>
            <a:off x="10763238" y="963771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B97C6A1-0249-965D-58F7-4906298716C4}"/>
              </a:ext>
            </a:extLst>
          </p:cNvPr>
          <p:cNvSpPr txBox="1"/>
          <p:nvPr/>
        </p:nvSpPr>
        <p:spPr>
          <a:xfrm>
            <a:off x="8496431" y="3127213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05667A3-F6D5-A72D-6C58-A1AE3D727DE7}"/>
              </a:ext>
            </a:extLst>
          </p:cNvPr>
          <p:cNvSpPr txBox="1"/>
          <p:nvPr/>
        </p:nvSpPr>
        <p:spPr>
          <a:xfrm>
            <a:off x="9193758" y="3118554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E7CD8C2-5C83-310F-EE45-8406ED798609}"/>
              </a:ext>
            </a:extLst>
          </p:cNvPr>
          <p:cNvSpPr txBox="1"/>
          <p:nvPr/>
        </p:nvSpPr>
        <p:spPr>
          <a:xfrm>
            <a:off x="9992074" y="3130994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A10B504-4281-5ADF-BA5C-476E1B3E7EF4}"/>
              </a:ext>
            </a:extLst>
          </p:cNvPr>
          <p:cNvSpPr txBox="1"/>
          <p:nvPr/>
        </p:nvSpPr>
        <p:spPr>
          <a:xfrm rot="16200000">
            <a:off x="7718402" y="2211342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</a:t>
            </a:r>
          </a:p>
        </p:txBody>
      </p:sp>
      <p:pic>
        <p:nvPicPr>
          <p:cNvPr id="47" name="Content Placeholder 6">
            <a:extLst>
              <a:ext uri="{FF2B5EF4-FFF2-40B4-BE49-F238E27FC236}">
                <a16:creationId xmlns:a16="http://schemas.microsoft.com/office/drawing/2014/main" id="{07C2A22B-62CE-477B-E3FA-EBAC884EAE0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95" r="8839" b="5707"/>
          <a:stretch/>
        </p:blipFill>
        <p:spPr>
          <a:xfrm>
            <a:off x="8071351" y="1204246"/>
            <a:ext cx="3258839" cy="1915127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32694979-F782-BD7E-C109-576A0D6D9BD6}"/>
              </a:ext>
            </a:extLst>
          </p:cNvPr>
          <p:cNvSpPr txBox="1"/>
          <p:nvPr/>
        </p:nvSpPr>
        <p:spPr>
          <a:xfrm>
            <a:off x="3325862" y="3794111"/>
            <a:ext cx="335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DEFFE6C-7A5B-2F37-D2B0-9876FC9FC80E}"/>
              </a:ext>
            </a:extLst>
          </p:cNvPr>
          <p:cNvSpPr txBox="1"/>
          <p:nvPr/>
        </p:nvSpPr>
        <p:spPr>
          <a:xfrm>
            <a:off x="3300061" y="3939060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Type 2</a:t>
            </a:r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E1F92CA5-042E-C14E-FBB4-900A2D85447B}"/>
              </a:ext>
            </a:extLst>
          </p:cNvPr>
          <p:cNvSpPr/>
          <p:nvPr/>
        </p:nvSpPr>
        <p:spPr>
          <a:xfrm>
            <a:off x="3217162" y="3885283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A5C8000C-1FE4-FA81-F630-4C41AE352261}"/>
              </a:ext>
            </a:extLst>
          </p:cNvPr>
          <p:cNvSpPr/>
          <p:nvPr/>
        </p:nvSpPr>
        <p:spPr>
          <a:xfrm>
            <a:off x="3217162" y="4021439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1C3E39A-A63C-60FE-B5EF-A1175075A85C}"/>
              </a:ext>
            </a:extLst>
          </p:cNvPr>
          <p:cNvSpPr txBox="1"/>
          <p:nvPr/>
        </p:nvSpPr>
        <p:spPr>
          <a:xfrm>
            <a:off x="683295" y="6317674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999AA25-842F-8DA7-3247-FED761FBB6F4}"/>
              </a:ext>
            </a:extLst>
          </p:cNvPr>
          <p:cNvSpPr txBox="1"/>
          <p:nvPr/>
        </p:nvSpPr>
        <p:spPr>
          <a:xfrm>
            <a:off x="1514152" y="6300297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63070C9-F80A-920B-2F13-4CCFC14C7991}"/>
              </a:ext>
            </a:extLst>
          </p:cNvPr>
          <p:cNvSpPr txBox="1"/>
          <p:nvPr/>
        </p:nvSpPr>
        <p:spPr>
          <a:xfrm>
            <a:off x="2445998" y="6300625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E6FF295-CD8A-99F5-93D1-8FF5D8DB42F1}"/>
              </a:ext>
            </a:extLst>
          </p:cNvPr>
          <p:cNvSpPr txBox="1"/>
          <p:nvPr/>
        </p:nvSpPr>
        <p:spPr>
          <a:xfrm rot="16200000">
            <a:off x="107166" y="5360502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4</a:t>
            </a:r>
          </a:p>
        </p:txBody>
      </p:sp>
      <p:pic>
        <p:nvPicPr>
          <p:cNvPr id="57" name="Content Placeholder 6">
            <a:extLst>
              <a:ext uri="{FF2B5EF4-FFF2-40B4-BE49-F238E27FC236}">
                <a16:creationId xmlns:a16="http://schemas.microsoft.com/office/drawing/2014/main" id="{4160A731-5391-ED4F-C34E-6E1426EF6746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9" r="9491" b="5866"/>
          <a:stretch/>
        </p:blipFill>
        <p:spPr>
          <a:xfrm>
            <a:off x="333929" y="4139796"/>
            <a:ext cx="3205616" cy="2195352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6E9DD75B-C404-C039-6855-0F411DB2EC65}"/>
              </a:ext>
            </a:extLst>
          </p:cNvPr>
          <p:cNvSpPr txBox="1"/>
          <p:nvPr/>
        </p:nvSpPr>
        <p:spPr>
          <a:xfrm>
            <a:off x="6920307" y="3810784"/>
            <a:ext cx="335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8D31217-7867-AD90-45B1-76EAFB1AFBCA}"/>
              </a:ext>
            </a:extLst>
          </p:cNvPr>
          <p:cNvSpPr txBox="1"/>
          <p:nvPr/>
        </p:nvSpPr>
        <p:spPr>
          <a:xfrm>
            <a:off x="6894506" y="3955733"/>
            <a:ext cx="49564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Type 2</a:t>
            </a:r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3B62D4DB-8870-DFAF-E2D0-8857CF4D4B09}"/>
              </a:ext>
            </a:extLst>
          </p:cNvPr>
          <p:cNvSpPr/>
          <p:nvPr/>
        </p:nvSpPr>
        <p:spPr>
          <a:xfrm>
            <a:off x="6811607" y="3901956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F6A211A7-42BA-72EB-CAD8-B3DA06BFF076}"/>
              </a:ext>
            </a:extLst>
          </p:cNvPr>
          <p:cNvSpPr/>
          <p:nvPr/>
        </p:nvSpPr>
        <p:spPr>
          <a:xfrm>
            <a:off x="6811607" y="4038112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973A639-C7A8-702F-36A0-0BEBDA761987}"/>
              </a:ext>
            </a:extLst>
          </p:cNvPr>
          <p:cNvSpPr txBox="1"/>
          <p:nvPr/>
        </p:nvSpPr>
        <p:spPr>
          <a:xfrm>
            <a:off x="4344589" y="634472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AC2B113-7862-5131-835B-7C7FCF7D2ECB}"/>
              </a:ext>
            </a:extLst>
          </p:cNvPr>
          <p:cNvSpPr txBox="1"/>
          <p:nvPr/>
        </p:nvSpPr>
        <p:spPr>
          <a:xfrm>
            <a:off x="5209586" y="6349796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40DC4860-85A8-DF7C-F2D6-035825D416DB}"/>
              </a:ext>
            </a:extLst>
          </p:cNvPr>
          <p:cNvSpPr txBox="1"/>
          <p:nvPr/>
        </p:nvSpPr>
        <p:spPr>
          <a:xfrm>
            <a:off x="6040443" y="6317298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803EAAB-DB40-CE65-5416-713CA0D04DCF}"/>
              </a:ext>
            </a:extLst>
          </p:cNvPr>
          <p:cNvSpPr txBox="1"/>
          <p:nvPr/>
        </p:nvSpPr>
        <p:spPr>
          <a:xfrm rot="16200000">
            <a:off x="3619238" y="5082697"/>
            <a:ext cx="5084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/H4</a:t>
            </a:r>
          </a:p>
        </p:txBody>
      </p:sp>
      <p:pic>
        <p:nvPicPr>
          <p:cNvPr id="67" name="Content Placeholder 6">
            <a:extLst>
              <a:ext uri="{FF2B5EF4-FFF2-40B4-BE49-F238E27FC236}">
                <a16:creationId xmlns:a16="http://schemas.microsoft.com/office/drawing/2014/main" id="{C9609617-91FD-9310-9EBB-CB5C05C969B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3" r="10327" b="5866"/>
          <a:stretch/>
        </p:blipFill>
        <p:spPr>
          <a:xfrm>
            <a:off x="3966352" y="4169892"/>
            <a:ext cx="3121335" cy="2195352"/>
          </a:xfrm>
          <a:prstGeom prst="rect">
            <a:avLst/>
          </a:prstGeom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087EEFE3-C2C9-FD90-6918-8C4B072D9358}"/>
              </a:ext>
            </a:extLst>
          </p:cNvPr>
          <p:cNvSpPr txBox="1"/>
          <p:nvPr/>
        </p:nvSpPr>
        <p:spPr>
          <a:xfrm>
            <a:off x="10938714" y="3820333"/>
            <a:ext cx="335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C6AED00A-8054-9EFA-A8E7-EE90D7CD3A69}"/>
              </a:ext>
            </a:extLst>
          </p:cNvPr>
          <p:cNvSpPr/>
          <p:nvPr/>
        </p:nvSpPr>
        <p:spPr>
          <a:xfrm>
            <a:off x="10830014" y="3911505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31DD126B-1AE5-B994-36DB-6EE328A9DAEE}"/>
              </a:ext>
            </a:extLst>
          </p:cNvPr>
          <p:cNvSpPr/>
          <p:nvPr/>
        </p:nvSpPr>
        <p:spPr>
          <a:xfrm>
            <a:off x="10830014" y="4047661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D01B3DA-021D-7669-89E2-DE7AFD28D991}"/>
              </a:ext>
            </a:extLst>
          </p:cNvPr>
          <p:cNvSpPr txBox="1"/>
          <p:nvPr/>
        </p:nvSpPr>
        <p:spPr>
          <a:xfrm>
            <a:off x="8417689" y="637236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18ACB07-B2F1-981B-9EFC-8BF07F8796C2}"/>
              </a:ext>
            </a:extLst>
          </p:cNvPr>
          <p:cNvSpPr txBox="1"/>
          <p:nvPr/>
        </p:nvSpPr>
        <p:spPr>
          <a:xfrm>
            <a:off x="9229290" y="6386601"/>
            <a:ext cx="6351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AF Status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E76247C-59E6-86EA-7CC7-F213456D6B09}"/>
              </a:ext>
            </a:extLst>
          </p:cNvPr>
          <p:cNvSpPr txBox="1"/>
          <p:nvPr/>
        </p:nvSpPr>
        <p:spPr>
          <a:xfrm>
            <a:off x="10073626" y="6372366"/>
            <a:ext cx="6896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BA72FB8-CE21-04D5-DF6F-8E712FE61D4E}"/>
              </a:ext>
            </a:extLst>
          </p:cNvPr>
          <p:cNvSpPr txBox="1"/>
          <p:nvPr/>
        </p:nvSpPr>
        <p:spPr>
          <a:xfrm rot="16200000">
            <a:off x="7445683" y="5214142"/>
            <a:ext cx="7713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croH2A1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677FC211-E36F-9274-610B-E24F2F0B8F8D}"/>
              </a:ext>
            </a:extLst>
          </p:cNvPr>
          <p:cNvSpPr txBox="1"/>
          <p:nvPr/>
        </p:nvSpPr>
        <p:spPr>
          <a:xfrm>
            <a:off x="10938714" y="3983069"/>
            <a:ext cx="50206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Type 2</a:t>
            </a:r>
          </a:p>
        </p:txBody>
      </p:sp>
      <p:pic>
        <p:nvPicPr>
          <p:cNvPr id="77" name="Content Placeholder 6">
            <a:extLst>
              <a:ext uri="{FF2B5EF4-FFF2-40B4-BE49-F238E27FC236}">
                <a16:creationId xmlns:a16="http://schemas.microsoft.com/office/drawing/2014/main" id="{43E53600-02E4-D05E-651D-99E1C323CC4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4" r="9659" b="5866"/>
          <a:stretch/>
        </p:blipFill>
        <p:spPr>
          <a:xfrm>
            <a:off x="7967621" y="4205484"/>
            <a:ext cx="3258839" cy="21953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3597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2</Words>
  <Application>Microsoft Macintosh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lio Vinciguera</dc:creator>
  <cp:lastModifiedBy>Manlio Vinciguera</cp:lastModifiedBy>
  <cp:revision>1</cp:revision>
  <dcterms:created xsi:type="dcterms:W3CDTF">2025-11-02T17:46:51Z</dcterms:created>
  <dcterms:modified xsi:type="dcterms:W3CDTF">2025-11-02T17:47:03Z</dcterms:modified>
</cp:coreProperties>
</file>